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6" autoAdjust="0"/>
    <p:restoredTop sz="94660"/>
  </p:normalViewPr>
  <p:slideViewPr>
    <p:cSldViewPr snapToGrid="0">
      <p:cViewPr varScale="1">
        <p:scale>
          <a:sx n="54" d="100"/>
          <a:sy n="54" d="100"/>
        </p:scale>
        <p:origin x="268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D-drijf%20jules%20march%202015\paper\Lee%20stages\Genes%20in%20leaf%20vs%20turnip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D-drijf%20jules%20march%202015\paper\Lee%20stages\Genes%20in%20leaf%20vs%20turnip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D-drijf%20jules%20march%202015\paper\Lee%20stages\Genes%20in%20leaf%20vs%20turnip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D-drijf%20jules%20march%202015\paper\Lee%20stages\Genes%20in%20leaf%20vs%20turnip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E:\D-drijf%20jules%20march%202015\paper\Lee%20stages\Genes%20in%20leaf%20vs%20turnip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E:\D-drijf%20jules%20march%202015\paper\Lee%20stages\Genes%20in%20leaf%20vs%20turnip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E:\D-drijf%20jules%20march%202015\paper\Lee%20stages\Genes%20in%20leaf%20vs%20turnip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1800" b="1" i="0" u="none" strike="noStrike" baseline="0" dirty="0">
                <a:effectLst/>
              </a:rPr>
              <a:t>MAM-Bra029355</a:t>
            </a:r>
            <a:endParaRPr lang="en-US" dirty="0"/>
          </a:p>
        </c:rich>
      </c:tx>
      <c:layout>
        <c:manualLayout>
          <c:xMode val="edge"/>
          <c:yMode val="edge"/>
          <c:x val="0.26630414559130794"/>
          <c:y val="0.2144926067607394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ammen!$AF$22</c:f>
              <c:strCache>
                <c:ptCount val="1"/>
                <c:pt idx="0">
                  <c:v>Mam1-pr50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mammen!$AG$23:$AG$34</c:f>
                <c:numCache>
                  <c:formatCode>General</c:formatCode>
                  <c:ptCount val="12"/>
                  <c:pt idx="0">
                    <c:v>0.62516664445036829</c:v>
                  </c:pt>
                  <c:pt idx="1">
                    <c:v>0.99026932363540876</c:v>
                  </c:pt>
                  <c:pt idx="2">
                    <c:v>0.23028967265887842</c:v>
                  </c:pt>
                  <c:pt idx="3">
                    <c:v>0.34428670223134289</c:v>
                  </c:pt>
                  <c:pt idx="4">
                    <c:v>0.23965252624024988</c:v>
                  </c:pt>
                  <c:pt idx="5">
                    <c:v>1.3221321164442426</c:v>
                  </c:pt>
                  <c:pt idx="6">
                    <c:v>0.92028980942599226</c:v>
                  </c:pt>
                  <c:pt idx="7">
                    <c:v>0.69310893804653784</c:v>
                  </c:pt>
                  <c:pt idx="8">
                    <c:v>2.4503673194033584</c:v>
                  </c:pt>
                  <c:pt idx="9">
                    <c:v>0.66523178917827785</c:v>
                  </c:pt>
                  <c:pt idx="10">
                    <c:v>0.41137979208188258</c:v>
                  </c:pt>
                  <c:pt idx="11">
                    <c:v>0.11718930554164987</c:v>
                  </c:pt>
                </c:numCache>
              </c:numRef>
            </c:plus>
            <c:minus>
              <c:numRef>
                <c:f>mammen!$AG$23:$AG$34</c:f>
                <c:numCache>
                  <c:formatCode>General</c:formatCode>
                  <c:ptCount val="12"/>
                  <c:pt idx="0">
                    <c:v>0.62516664445036829</c:v>
                  </c:pt>
                  <c:pt idx="1">
                    <c:v>0.99026932363540876</c:v>
                  </c:pt>
                  <c:pt idx="2">
                    <c:v>0.23028967265887842</c:v>
                  </c:pt>
                  <c:pt idx="3">
                    <c:v>0.34428670223134289</c:v>
                  </c:pt>
                  <c:pt idx="4">
                    <c:v>0.23965252624024988</c:v>
                  </c:pt>
                  <c:pt idx="5">
                    <c:v>1.3221321164442426</c:v>
                  </c:pt>
                  <c:pt idx="6">
                    <c:v>0.92028980942599226</c:v>
                  </c:pt>
                  <c:pt idx="7">
                    <c:v>0.69310893804653784</c:v>
                  </c:pt>
                  <c:pt idx="8">
                    <c:v>2.4503673194033584</c:v>
                  </c:pt>
                  <c:pt idx="9">
                    <c:v>0.66523178917827785</c:v>
                  </c:pt>
                  <c:pt idx="10">
                    <c:v>0.41137979208188258</c:v>
                  </c:pt>
                  <c:pt idx="11">
                    <c:v>0.11718930554164987</c:v>
                  </c:pt>
                </c:numCache>
              </c:numRef>
            </c:minus>
          </c:errBars>
          <c:cat>
            <c:strRef>
              <c:f>mammen!$AE$23:$AE$34</c:f>
              <c:strCache>
                <c:ptCount val="12"/>
                <c:pt idx="0">
                  <c:v>T2-YL</c:v>
                </c:pt>
                <c:pt idx="1">
                  <c:v>T6-YL</c:v>
                </c:pt>
                <c:pt idx="2">
                  <c:v>T6-OL</c:v>
                </c:pt>
                <c:pt idx="3">
                  <c:v>T2-YL</c:v>
                </c:pt>
                <c:pt idx="4">
                  <c:v>T6-YL</c:v>
                </c:pt>
                <c:pt idx="5">
                  <c:v>T6-OL</c:v>
                </c:pt>
                <c:pt idx="6">
                  <c:v>T2</c:v>
                </c:pt>
                <c:pt idx="7">
                  <c:v>T3</c:v>
                </c:pt>
                <c:pt idx="8">
                  <c:v>T6</c:v>
                </c:pt>
                <c:pt idx="9">
                  <c:v>T2</c:v>
                </c:pt>
                <c:pt idx="10">
                  <c:v>T3</c:v>
                </c:pt>
                <c:pt idx="11">
                  <c:v>T6</c:v>
                </c:pt>
              </c:strCache>
            </c:strRef>
          </c:cat>
          <c:val>
            <c:numRef>
              <c:f>mammen!$AF$23:$AF$34</c:f>
              <c:numCache>
                <c:formatCode>General</c:formatCode>
                <c:ptCount val="12"/>
                <c:pt idx="0">
                  <c:v>-3.9433333333333338</c:v>
                </c:pt>
                <c:pt idx="1">
                  <c:v>-6.6433333333333335</c:v>
                </c:pt>
                <c:pt idx="2">
                  <c:v>-6.6866666666666674</c:v>
                </c:pt>
                <c:pt idx="3">
                  <c:v>-3.8666666666666671</c:v>
                </c:pt>
                <c:pt idx="4">
                  <c:v>-3.7666666666666657</c:v>
                </c:pt>
                <c:pt idx="5">
                  <c:v>-4.9166666666666652</c:v>
                </c:pt>
                <c:pt idx="6">
                  <c:v>-8.1666666666666661</c:v>
                </c:pt>
                <c:pt idx="7">
                  <c:v>-8.7000000000000011</c:v>
                </c:pt>
                <c:pt idx="8">
                  <c:v>-15.14</c:v>
                </c:pt>
                <c:pt idx="9">
                  <c:v>-6.1433333333333335</c:v>
                </c:pt>
                <c:pt idx="10">
                  <c:v>-4.9466666666666663</c:v>
                </c:pt>
                <c:pt idx="11">
                  <c:v>-11.64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CAA-4BE3-A959-22C7D60F47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236800"/>
        <c:axId val="130238336"/>
      </c:barChart>
      <c:catAx>
        <c:axId val="1302368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5400000" vert="horz"/>
          <a:lstStyle/>
          <a:p>
            <a:pPr>
              <a:defRPr/>
            </a:pPr>
            <a:endParaRPr lang="nl-NL"/>
          </a:p>
        </c:txPr>
        <c:crossAx val="130238336"/>
        <c:crossesAt val="-12"/>
        <c:auto val="1"/>
        <c:lblAlgn val="ctr"/>
        <c:lblOffset val="100"/>
        <c:noMultiLvlLbl val="0"/>
      </c:catAx>
      <c:valAx>
        <c:axId val="130238336"/>
        <c:scaling>
          <c:orientation val="minMax"/>
          <c:max val="0"/>
          <c:min val="-12"/>
        </c:scaling>
        <c:delete val="0"/>
        <c:axPos val="l"/>
        <c:numFmt formatCode="General" sourceLinked="1"/>
        <c:majorTickMark val="out"/>
        <c:minorTickMark val="none"/>
        <c:tickLblPos val="nextTo"/>
        <c:crossAx val="130236800"/>
        <c:crosses val="autoZero"/>
        <c:crossBetween val="between"/>
        <c:majorUnit val="2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1800" b="1" i="0" u="none" strike="noStrike" baseline="0" dirty="0">
                <a:effectLst/>
              </a:rPr>
              <a:t>MAM-Bra013007</a:t>
            </a:r>
            <a:endParaRPr lang="en-US" dirty="0"/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ammen!$AF$3</c:f>
              <c:strCache>
                <c:ptCount val="1"/>
                <c:pt idx="0">
                  <c:v>Mam1-pr 46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mammen!$AG$4:$AG$15</c:f>
                <c:numCache>
                  <c:formatCode>General</c:formatCode>
                  <c:ptCount val="12"/>
                  <c:pt idx="0">
                    <c:v>0.24758836806279869</c:v>
                  </c:pt>
                  <c:pt idx="1">
                    <c:v>0.66010100237261682</c:v>
                  </c:pt>
                  <c:pt idx="2">
                    <c:v>0.46130250378683124</c:v>
                  </c:pt>
                  <c:pt idx="3">
                    <c:v>0.25501633934580298</c:v>
                  </c:pt>
                  <c:pt idx="4">
                    <c:v>0.47511402140258258</c:v>
                  </c:pt>
                  <c:pt idx="5">
                    <c:v>1.3914500829470422</c:v>
                  </c:pt>
                  <c:pt idx="6">
                    <c:v>2.1414325423261262</c:v>
                  </c:pt>
                  <c:pt idx="7">
                    <c:v>0.6784049921199965</c:v>
                  </c:pt>
                  <c:pt idx="8">
                    <c:v>1.0950342460398244</c:v>
                  </c:pt>
                  <c:pt idx="9">
                    <c:v>0.45742030271221418</c:v>
                  </c:pt>
                  <c:pt idx="10">
                    <c:v>0.43924177093410954</c:v>
                  </c:pt>
                  <c:pt idx="11">
                    <c:v>0.52814139520902248</c:v>
                  </c:pt>
                </c:numCache>
              </c:numRef>
            </c:plus>
            <c:minus>
              <c:numRef>
                <c:f>mammen!$AG$4:$AG$15</c:f>
                <c:numCache>
                  <c:formatCode>General</c:formatCode>
                  <c:ptCount val="12"/>
                  <c:pt idx="0">
                    <c:v>0.24758836806279869</c:v>
                  </c:pt>
                  <c:pt idx="1">
                    <c:v>0.66010100237261682</c:v>
                  </c:pt>
                  <c:pt idx="2">
                    <c:v>0.46130250378683124</c:v>
                  </c:pt>
                  <c:pt idx="3">
                    <c:v>0.25501633934580298</c:v>
                  </c:pt>
                  <c:pt idx="4">
                    <c:v>0.47511402140258258</c:v>
                  </c:pt>
                  <c:pt idx="5">
                    <c:v>1.3914500829470422</c:v>
                  </c:pt>
                  <c:pt idx="6">
                    <c:v>2.1414325423261262</c:v>
                  </c:pt>
                  <c:pt idx="7">
                    <c:v>0.6784049921199965</c:v>
                  </c:pt>
                  <c:pt idx="8">
                    <c:v>1.0950342460398244</c:v>
                  </c:pt>
                  <c:pt idx="9">
                    <c:v>0.45742030271221418</c:v>
                  </c:pt>
                  <c:pt idx="10">
                    <c:v>0.43924177093410954</c:v>
                  </c:pt>
                  <c:pt idx="11">
                    <c:v>0.52814139520902248</c:v>
                  </c:pt>
                </c:numCache>
              </c:numRef>
            </c:minus>
          </c:errBars>
          <c:cat>
            <c:strRef>
              <c:f>mammen!$AE$4:$AE$15</c:f>
              <c:strCache>
                <c:ptCount val="12"/>
                <c:pt idx="0">
                  <c:v>T2-YL</c:v>
                </c:pt>
                <c:pt idx="1">
                  <c:v>T6-YL</c:v>
                </c:pt>
                <c:pt idx="2">
                  <c:v>T6-OL</c:v>
                </c:pt>
                <c:pt idx="3">
                  <c:v>T2-YL</c:v>
                </c:pt>
                <c:pt idx="4">
                  <c:v>T6-YL</c:v>
                </c:pt>
                <c:pt idx="5">
                  <c:v>T6-OL</c:v>
                </c:pt>
                <c:pt idx="6">
                  <c:v>T2</c:v>
                </c:pt>
                <c:pt idx="7">
                  <c:v>T3</c:v>
                </c:pt>
                <c:pt idx="8">
                  <c:v>T6</c:v>
                </c:pt>
                <c:pt idx="9">
                  <c:v>T2</c:v>
                </c:pt>
                <c:pt idx="10">
                  <c:v>T3</c:v>
                </c:pt>
                <c:pt idx="11">
                  <c:v>T6</c:v>
                </c:pt>
              </c:strCache>
            </c:strRef>
          </c:cat>
          <c:val>
            <c:numRef>
              <c:f>mammen!$AF$4:$AF$15</c:f>
              <c:numCache>
                <c:formatCode>General</c:formatCode>
                <c:ptCount val="12"/>
                <c:pt idx="0">
                  <c:v>-2.35</c:v>
                </c:pt>
                <c:pt idx="1">
                  <c:v>-5.7533333333333339</c:v>
                </c:pt>
                <c:pt idx="2">
                  <c:v>-6.7200000000000015</c:v>
                </c:pt>
                <c:pt idx="3">
                  <c:v>-3.9433333333333351</c:v>
                </c:pt>
                <c:pt idx="4">
                  <c:v>-4.1366666666666667</c:v>
                </c:pt>
                <c:pt idx="5">
                  <c:v>-4.8033333333333319</c:v>
                </c:pt>
                <c:pt idx="6">
                  <c:v>-7.6733333333333329</c:v>
                </c:pt>
                <c:pt idx="7">
                  <c:v>-9.3033333333333328</c:v>
                </c:pt>
                <c:pt idx="8">
                  <c:v>-16.09</c:v>
                </c:pt>
                <c:pt idx="9">
                  <c:v>-8.0366666666666671</c:v>
                </c:pt>
                <c:pt idx="10">
                  <c:v>-6.6566666666666672</c:v>
                </c:pt>
                <c:pt idx="11">
                  <c:v>-14.11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3B2-4319-A706-0FB5344B06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267008"/>
        <c:axId val="130268544"/>
      </c:barChart>
      <c:catAx>
        <c:axId val="1302670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5400000" vert="horz"/>
          <a:lstStyle/>
          <a:p>
            <a:pPr>
              <a:defRPr/>
            </a:pPr>
            <a:endParaRPr lang="nl-NL"/>
          </a:p>
        </c:txPr>
        <c:crossAx val="130268544"/>
        <c:crossesAt val="-12"/>
        <c:auto val="1"/>
        <c:lblAlgn val="ctr"/>
        <c:lblOffset val="100"/>
        <c:noMultiLvlLbl val="0"/>
      </c:catAx>
      <c:valAx>
        <c:axId val="130268544"/>
        <c:scaling>
          <c:orientation val="minMax"/>
          <c:max val="0"/>
          <c:min val="-12"/>
        </c:scaling>
        <c:delete val="0"/>
        <c:axPos val="l"/>
        <c:numFmt formatCode="General" sourceLinked="1"/>
        <c:majorTickMark val="out"/>
        <c:minorTickMark val="none"/>
        <c:tickLblPos val="nextTo"/>
        <c:crossAx val="130267008"/>
        <c:crosses val="autoZero"/>
        <c:crossBetween val="between"/>
        <c:majorUnit val="2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1800" b="1" i="0" u="none" strike="noStrike" baseline="0" dirty="0">
                <a:effectLst/>
              </a:rPr>
              <a:t>MAM-Bra018524</a:t>
            </a:r>
            <a:endParaRPr lang="en-US" dirty="0"/>
          </a:p>
        </c:rich>
      </c:tx>
      <c:layout>
        <c:manualLayout>
          <c:xMode val="edge"/>
          <c:yMode val="edge"/>
          <c:x val="0.26258302565726843"/>
          <c:y val="0.2144926067607394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ammen!$AF$39</c:f>
              <c:strCache>
                <c:ptCount val="1"/>
                <c:pt idx="0">
                  <c:v>mam1 pr47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mammen!$AG$40:$AG$51</c:f>
                <c:numCache>
                  <c:formatCode>General</c:formatCode>
                  <c:ptCount val="12"/>
                  <c:pt idx="0">
                    <c:v>0.40278199231511619</c:v>
                  </c:pt>
                  <c:pt idx="1">
                    <c:v>0.23629078131263054</c:v>
                  </c:pt>
                  <c:pt idx="2">
                    <c:v>0.38888730158406021</c:v>
                  </c:pt>
                  <c:pt idx="3">
                    <c:v>0.22143471573656659</c:v>
                  </c:pt>
                  <c:pt idx="4">
                    <c:v>0.61614392258086392</c:v>
                  </c:pt>
                  <c:pt idx="5">
                    <c:v>1.3006280534162469</c:v>
                  </c:pt>
                  <c:pt idx="6">
                    <c:v>1.2056671735322908</c:v>
                  </c:pt>
                  <c:pt idx="7">
                    <c:v>0.62228075121550452</c:v>
                  </c:pt>
                  <c:pt idx="8">
                    <c:v>0.80525358324774432</c:v>
                  </c:pt>
                  <c:pt idx="9">
                    <c:v>1.00164864099144</c:v>
                  </c:pt>
                  <c:pt idx="10">
                    <c:v>0.40673496694202932</c:v>
                  </c:pt>
                  <c:pt idx="11">
                    <c:v>1.5400000000000187</c:v>
                  </c:pt>
                </c:numCache>
              </c:numRef>
            </c:plus>
            <c:minus>
              <c:numRef>
                <c:f>mammen!$AG$40:$AG$51</c:f>
                <c:numCache>
                  <c:formatCode>General</c:formatCode>
                  <c:ptCount val="12"/>
                  <c:pt idx="0">
                    <c:v>0.40278199231511619</c:v>
                  </c:pt>
                  <c:pt idx="1">
                    <c:v>0.23629078131263054</c:v>
                  </c:pt>
                  <c:pt idx="2">
                    <c:v>0.38888730158406021</c:v>
                  </c:pt>
                  <c:pt idx="3">
                    <c:v>0.22143471573656659</c:v>
                  </c:pt>
                  <c:pt idx="4">
                    <c:v>0.61614392258086392</c:v>
                  </c:pt>
                  <c:pt idx="5">
                    <c:v>1.3006280534162469</c:v>
                  </c:pt>
                  <c:pt idx="6">
                    <c:v>1.2056671735322908</c:v>
                  </c:pt>
                  <c:pt idx="7">
                    <c:v>0.62228075121550452</c:v>
                  </c:pt>
                  <c:pt idx="8">
                    <c:v>0.80525358324774432</c:v>
                  </c:pt>
                  <c:pt idx="9">
                    <c:v>1.00164864099144</c:v>
                  </c:pt>
                  <c:pt idx="10">
                    <c:v>0.40673496694202932</c:v>
                  </c:pt>
                  <c:pt idx="11">
                    <c:v>1.5400000000000187</c:v>
                  </c:pt>
                </c:numCache>
              </c:numRef>
            </c:minus>
          </c:errBars>
          <c:cat>
            <c:strRef>
              <c:f>mammen!$AE$40:$AE$51</c:f>
              <c:strCache>
                <c:ptCount val="12"/>
                <c:pt idx="0">
                  <c:v>T2-YL</c:v>
                </c:pt>
                <c:pt idx="1">
                  <c:v>T6-YL</c:v>
                </c:pt>
                <c:pt idx="2">
                  <c:v>T6-OL</c:v>
                </c:pt>
                <c:pt idx="3">
                  <c:v>T2-YL</c:v>
                </c:pt>
                <c:pt idx="4">
                  <c:v>T6-YL</c:v>
                </c:pt>
                <c:pt idx="5">
                  <c:v>T6-OL</c:v>
                </c:pt>
                <c:pt idx="6">
                  <c:v>T2</c:v>
                </c:pt>
                <c:pt idx="7">
                  <c:v>T3</c:v>
                </c:pt>
                <c:pt idx="8">
                  <c:v>T6</c:v>
                </c:pt>
                <c:pt idx="9">
                  <c:v>T2</c:v>
                </c:pt>
                <c:pt idx="10">
                  <c:v>T3</c:v>
                </c:pt>
                <c:pt idx="11">
                  <c:v>T6</c:v>
                </c:pt>
              </c:strCache>
            </c:strRef>
          </c:cat>
          <c:val>
            <c:numRef>
              <c:f>mammen!$AF$40:$AF$51</c:f>
              <c:numCache>
                <c:formatCode>General</c:formatCode>
                <c:ptCount val="12"/>
                <c:pt idx="0">
                  <c:v>-4.2433333333333332</c:v>
                </c:pt>
                <c:pt idx="1">
                  <c:v>-7.2633333333333345</c:v>
                </c:pt>
                <c:pt idx="2">
                  <c:v>-7.8233333333333341</c:v>
                </c:pt>
                <c:pt idx="3">
                  <c:v>-4.3966666666666674</c:v>
                </c:pt>
                <c:pt idx="4">
                  <c:v>-5.2433333333333323</c:v>
                </c:pt>
                <c:pt idx="5">
                  <c:v>-5.6066666666666665</c:v>
                </c:pt>
                <c:pt idx="6">
                  <c:v>-8.9666666666666668</c:v>
                </c:pt>
                <c:pt idx="7">
                  <c:v>-10.136666666666668</c:v>
                </c:pt>
                <c:pt idx="8">
                  <c:v>-11.423333333333332</c:v>
                </c:pt>
                <c:pt idx="9">
                  <c:v>-8.44</c:v>
                </c:pt>
                <c:pt idx="10">
                  <c:v>-6.6866666666666674</c:v>
                </c:pt>
                <c:pt idx="11">
                  <c:v>-11.33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50-4EBB-9E45-DBF28CE5D4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305408"/>
        <c:axId val="130307200"/>
      </c:barChart>
      <c:catAx>
        <c:axId val="1303054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5400000" vert="horz"/>
          <a:lstStyle/>
          <a:p>
            <a:pPr>
              <a:defRPr/>
            </a:pPr>
            <a:endParaRPr lang="nl-NL"/>
          </a:p>
        </c:txPr>
        <c:crossAx val="130307200"/>
        <c:crossesAt val="-12"/>
        <c:auto val="1"/>
        <c:lblAlgn val="ctr"/>
        <c:lblOffset val="100"/>
        <c:noMultiLvlLbl val="0"/>
      </c:catAx>
      <c:valAx>
        <c:axId val="130307200"/>
        <c:scaling>
          <c:orientation val="minMax"/>
          <c:max val="0"/>
          <c:min val="-12"/>
        </c:scaling>
        <c:delete val="0"/>
        <c:axPos val="l"/>
        <c:numFmt formatCode="General" sourceLinked="1"/>
        <c:majorTickMark val="out"/>
        <c:minorTickMark val="none"/>
        <c:tickLblPos val="nextTo"/>
        <c:crossAx val="130305408"/>
        <c:crosses val="autoZero"/>
        <c:crossBetween val="between"/>
        <c:majorUnit val="2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1800" b="1" i="0" u="none" strike="noStrike" baseline="0" dirty="0">
                <a:effectLst/>
              </a:rPr>
              <a:t>MAM-Bra013011</a:t>
            </a:r>
            <a:endParaRPr lang="en-US" dirty="0"/>
          </a:p>
        </c:rich>
      </c:tx>
      <c:layout>
        <c:manualLayout>
          <c:xMode val="edge"/>
          <c:yMode val="edge"/>
          <c:x val="0.26258302565726843"/>
          <c:y val="0.17664097027355011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ammen!$AS$22</c:f>
              <c:strCache>
                <c:ptCount val="1"/>
                <c:pt idx="0">
                  <c:v>mam3-pr53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mammen!$AT$23:$AT$34</c:f>
                <c:numCache>
                  <c:formatCode>General</c:formatCode>
                  <c:ptCount val="12"/>
                  <c:pt idx="0">
                    <c:v>0.73582153633427572</c:v>
                  </c:pt>
                  <c:pt idx="1">
                    <c:v>0.1153256259467058</c:v>
                  </c:pt>
                  <c:pt idx="2">
                    <c:v>0.46306946923040954</c:v>
                  </c:pt>
                  <c:pt idx="3">
                    <c:v>0.17578395831247076</c:v>
                  </c:pt>
                  <c:pt idx="4">
                    <c:v>0.22810816147900859</c:v>
                  </c:pt>
                  <c:pt idx="5">
                    <c:v>1.3901198989056061</c:v>
                  </c:pt>
                  <c:pt idx="6">
                    <c:v>0.87429971977577281</c:v>
                  </c:pt>
                  <c:pt idx="7">
                    <c:v>0.49034001808268957</c:v>
                  </c:pt>
                  <c:pt idx="8">
                    <c:v>0.82346827504160813</c:v>
                  </c:pt>
                  <c:pt idx="9">
                    <c:v>0.20502032419575786</c:v>
                  </c:pt>
                  <c:pt idx="10">
                    <c:v>0.52785730394997077</c:v>
                  </c:pt>
                  <c:pt idx="11">
                    <c:v>1.4243946082459049</c:v>
                  </c:pt>
                </c:numCache>
              </c:numRef>
            </c:plus>
            <c:minus>
              <c:numRef>
                <c:f>mammen!$AT$23:$AT$34</c:f>
                <c:numCache>
                  <c:formatCode>General</c:formatCode>
                  <c:ptCount val="12"/>
                  <c:pt idx="0">
                    <c:v>0.73582153633427572</c:v>
                  </c:pt>
                  <c:pt idx="1">
                    <c:v>0.1153256259467058</c:v>
                  </c:pt>
                  <c:pt idx="2">
                    <c:v>0.46306946923040954</c:v>
                  </c:pt>
                  <c:pt idx="3">
                    <c:v>0.17578395831247076</c:v>
                  </c:pt>
                  <c:pt idx="4">
                    <c:v>0.22810816147900859</c:v>
                  </c:pt>
                  <c:pt idx="5">
                    <c:v>1.3901198989056061</c:v>
                  </c:pt>
                  <c:pt idx="6">
                    <c:v>0.87429971977577281</c:v>
                  </c:pt>
                  <c:pt idx="7">
                    <c:v>0.49034001808268957</c:v>
                  </c:pt>
                  <c:pt idx="8">
                    <c:v>0.82346827504160813</c:v>
                  </c:pt>
                  <c:pt idx="9">
                    <c:v>0.20502032419575786</c:v>
                  </c:pt>
                  <c:pt idx="10">
                    <c:v>0.52785730394997077</c:v>
                  </c:pt>
                  <c:pt idx="11">
                    <c:v>1.4243946082459049</c:v>
                  </c:pt>
                </c:numCache>
              </c:numRef>
            </c:minus>
          </c:errBars>
          <c:cat>
            <c:strRef>
              <c:f>mammen!$AR$23:$AR$34</c:f>
              <c:strCache>
                <c:ptCount val="12"/>
                <c:pt idx="0">
                  <c:v>T2-YL</c:v>
                </c:pt>
                <c:pt idx="1">
                  <c:v>T6-YL</c:v>
                </c:pt>
                <c:pt idx="2">
                  <c:v>T6-OL</c:v>
                </c:pt>
                <c:pt idx="3">
                  <c:v>T2-YL</c:v>
                </c:pt>
                <c:pt idx="4">
                  <c:v>T6-YL</c:v>
                </c:pt>
                <c:pt idx="5">
                  <c:v>T6-OL</c:v>
                </c:pt>
                <c:pt idx="6">
                  <c:v>T2</c:v>
                </c:pt>
                <c:pt idx="7">
                  <c:v>T3</c:v>
                </c:pt>
                <c:pt idx="8">
                  <c:v>T6</c:v>
                </c:pt>
                <c:pt idx="9">
                  <c:v>T2</c:v>
                </c:pt>
                <c:pt idx="10">
                  <c:v>T3</c:v>
                </c:pt>
                <c:pt idx="11">
                  <c:v>T6</c:v>
                </c:pt>
              </c:strCache>
            </c:strRef>
          </c:cat>
          <c:val>
            <c:numRef>
              <c:f>mammen!$AS$23:$AS$34</c:f>
              <c:numCache>
                <c:formatCode>General</c:formatCode>
                <c:ptCount val="12"/>
                <c:pt idx="0">
                  <c:v>-3.0333333333333337</c:v>
                </c:pt>
                <c:pt idx="1">
                  <c:v>-5.7600000000000007</c:v>
                </c:pt>
                <c:pt idx="2">
                  <c:v>-6.3933333333333344</c:v>
                </c:pt>
                <c:pt idx="3">
                  <c:v>-3.9500000000000015</c:v>
                </c:pt>
                <c:pt idx="4">
                  <c:v>-3.9666666666666663</c:v>
                </c:pt>
                <c:pt idx="5">
                  <c:v>-3.7633333333333332</c:v>
                </c:pt>
                <c:pt idx="6">
                  <c:v>-5.5700000000000012</c:v>
                </c:pt>
                <c:pt idx="7">
                  <c:v>-8.3766666666666669</c:v>
                </c:pt>
                <c:pt idx="8">
                  <c:v>-12.159999999999998</c:v>
                </c:pt>
                <c:pt idx="9">
                  <c:v>-5.9466666666666654</c:v>
                </c:pt>
                <c:pt idx="10">
                  <c:v>-5.5933333333333337</c:v>
                </c:pt>
                <c:pt idx="11">
                  <c:v>-12.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DF9-4479-BE5F-46339F94B7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331776"/>
        <c:axId val="130333312"/>
      </c:barChart>
      <c:catAx>
        <c:axId val="1303317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5400000" vert="horz"/>
          <a:lstStyle/>
          <a:p>
            <a:pPr>
              <a:defRPr/>
            </a:pPr>
            <a:endParaRPr lang="nl-NL"/>
          </a:p>
        </c:txPr>
        <c:crossAx val="130333312"/>
        <c:crossesAt val="-12"/>
        <c:auto val="1"/>
        <c:lblAlgn val="ctr"/>
        <c:lblOffset val="100"/>
        <c:noMultiLvlLbl val="0"/>
      </c:catAx>
      <c:valAx>
        <c:axId val="130333312"/>
        <c:scaling>
          <c:orientation val="minMax"/>
          <c:max val="0"/>
          <c:min val="-12"/>
        </c:scaling>
        <c:delete val="0"/>
        <c:axPos val="l"/>
        <c:numFmt formatCode="General" sourceLinked="1"/>
        <c:majorTickMark val="out"/>
        <c:minorTickMark val="none"/>
        <c:tickLblPos val="nextTo"/>
        <c:crossAx val="130331776"/>
        <c:crosses val="autoZero"/>
        <c:crossBetween val="between"/>
        <c:majorUnit val="2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1800" b="1" i="0" u="none" strike="noStrike" baseline="0" dirty="0">
                <a:effectLst/>
              </a:rPr>
              <a:t>MAM-Bra029356</a:t>
            </a:r>
            <a:endParaRPr lang="en-US" dirty="0"/>
          </a:p>
        </c:rich>
      </c:tx>
      <c:layout>
        <c:manualLayout>
          <c:xMode val="edge"/>
          <c:yMode val="edge"/>
          <c:x val="0.25141966585514997"/>
          <c:y val="0.17664097027355011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ammen!$AS$39</c:f>
              <c:strCache>
                <c:ptCount val="1"/>
                <c:pt idx="0">
                  <c:v>mam3 pr57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mammen!$AT$40:$AT$51</c:f>
                <c:numCache>
                  <c:formatCode>General</c:formatCode>
                  <c:ptCount val="12"/>
                  <c:pt idx="0">
                    <c:v>0.89187069316876399</c:v>
                  </c:pt>
                  <c:pt idx="1">
                    <c:v>0.24979991993593459</c:v>
                  </c:pt>
                  <c:pt idx="2">
                    <c:v>0.27209067116190161</c:v>
                  </c:pt>
                  <c:pt idx="3">
                    <c:v>0.28160255680657509</c:v>
                  </c:pt>
                  <c:pt idx="4">
                    <c:v>8.6216781042518037E-2</c:v>
                  </c:pt>
                  <c:pt idx="5">
                    <c:v>1.4129048092493697</c:v>
                  </c:pt>
                  <c:pt idx="6">
                    <c:v>0.85807925041920974</c:v>
                  </c:pt>
                  <c:pt idx="7">
                    <c:v>0.35795716689756973</c:v>
                  </c:pt>
                  <c:pt idx="8">
                    <c:v>1.8100092080797099</c:v>
                  </c:pt>
                  <c:pt idx="9">
                    <c:v>0.13453624047073792</c:v>
                  </c:pt>
                  <c:pt idx="10">
                    <c:v>0.65056385799806671</c:v>
                  </c:pt>
                  <c:pt idx="11">
                    <c:v>1.0670676329705329</c:v>
                  </c:pt>
                </c:numCache>
              </c:numRef>
            </c:plus>
            <c:minus>
              <c:numRef>
                <c:f>mammen!$AT$40:$AT$51</c:f>
                <c:numCache>
                  <c:formatCode>General</c:formatCode>
                  <c:ptCount val="12"/>
                  <c:pt idx="0">
                    <c:v>0.89187069316876399</c:v>
                  </c:pt>
                  <c:pt idx="1">
                    <c:v>0.24979991993593459</c:v>
                  </c:pt>
                  <c:pt idx="2">
                    <c:v>0.27209067116190161</c:v>
                  </c:pt>
                  <c:pt idx="3">
                    <c:v>0.28160255680657509</c:v>
                  </c:pt>
                  <c:pt idx="4">
                    <c:v>8.6216781042518037E-2</c:v>
                  </c:pt>
                  <c:pt idx="5">
                    <c:v>1.4129048092493697</c:v>
                  </c:pt>
                  <c:pt idx="6">
                    <c:v>0.85807925041920974</c:v>
                  </c:pt>
                  <c:pt idx="7">
                    <c:v>0.35795716689756973</c:v>
                  </c:pt>
                  <c:pt idx="8">
                    <c:v>1.8100092080797099</c:v>
                  </c:pt>
                  <c:pt idx="9">
                    <c:v>0.13453624047073792</c:v>
                  </c:pt>
                  <c:pt idx="10">
                    <c:v>0.65056385799806671</c:v>
                  </c:pt>
                  <c:pt idx="11">
                    <c:v>1.0670676329705329</c:v>
                  </c:pt>
                </c:numCache>
              </c:numRef>
            </c:minus>
          </c:errBars>
          <c:cat>
            <c:strRef>
              <c:f>mammen!$AE$40:$AE$51</c:f>
              <c:strCache>
                <c:ptCount val="12"/>
                <c:pt idx="0">
                  <c:v>T2-YL</c:v>
                </c:pt>
                <c:pt idx="1">
                  <c:v>T6-YL</c:v>
                </c:pt>
                <c:pt idx="2">
                  <c:v>T6-OL</c:v>
                </c:pt>
                <c:pt idx="3">
                  <c:v>T2-YL</c:v>
                </c:pt>
                <c:pt idx="4">
                  <c:v>T6-YL</c:v>
                </c:pt>
                <c:pt idx="5">
                  <c:v>T6-OL</c:v>
                </c:pt>
                <c:pt idx="6">
                  <c:v>T2</c:v>
                </c:pt>
                <c:pt idx="7">
                  <c:v>T3</c:v>
                </c:pt>
                <c:pt idx="8">
                  <c:v>T6</c:v>
                </c:pt>
                <c:pt idx="9">
                  <c:v>T2</c:v>
                </c:pt>
                <c:pt idx="10">
                  <c:v>T3</c:v>
                </c:pt>
                <c:pt idx="11">
                  <c:v>T6</c:v>
                </c:pt>
              </c:strCache>
            </c:strRef>
          </c:cat>
          <c:val>
            <c:numRef>
              <c:f>mammen!$AS$40:$AS$51</c:f>
              <c:numCache>
                <c:formatCode>General</c:formatCode>
                <c:ptCount val="12"/>
                <c:pt idx="0">
                  <c:v>-3.0133333333333332</c:v>
                </c:pt>
                <c:pt idx="1">
                  <c:v>-5.45</c:v>
                </c:pt>
                <c:pt idx="2">
                  <c:v>-5.873333333333334</c:v>
                </c:pt>
                <c:pt idx="3">
                  <c:v>-3.2400000000000007</c:v>
                </c:pt>
                <c:pt idx="4">
                  <c:v>-3.6333333333333329</c:v>
                </c:pt>
                <c:pt idx="5">
                  <c:v>-3.6699999999999995</c:v>
                </c:pt>
                <c:pt idx="6">
                  <c:v>-5.3500000000000005</c:v>
                </c:pt>
                <c:pt idx="7">
                  <c:v>-8.0233333333333334</c:v>
                </c:pt>
                <c:pt idx="8">
                  <c:v>-16.153333333333332</c:v>
                </c:pt>
                <c:pt idx="9">
                  <c:v>-5.3299999999999992</c:v>
                </c:pt>
                <c:pt idx="10">
                  <c:v>-4.8766666666666678</c:v>
                </c:pt>
                <c:pt idx="11">
                  <c:v>-12.3166666666666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3B1-4CE4-B671-6E8FF5D460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345600"/>
        <c:axId val="130625920"/>
      </c:barChart>
      <c:catAx>
        <c:axId val="1303456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5400000" vert="horz"/>
          <a:lstStyle/>
          <a:p>
            <a:pPr>
              <a:defRPr/>
            </a:pPr>
            <a:endParaRPr lang="nl-NL"/>
          </a:p>
        </c:txPr>
        <c:crossAx val="130625920"/>
        <c:crossesAt val="-12"/>
        <c:auto val="1"/>
        <c:lblAlgn val="ctr"/>
        <c:lblOffset val="100"/>
        <c:noMultiLvlLbl val="0"/>
      </c:catAx>
      <c:valAx>
        <c:axId val="130625920"/>
        <c:scaling>
          <c:orientation val="minMax"/>
          <c:max val="0"/>
          <c:min val="-12"/>
        </c:scaling>
        <c:delete val="0"/>
        <c:axPos val="l"/>
        <c:numFmt formatCode="General" sourceLinked="1"/>
        <c:majorTickMark val="out"/>
        <c:minorTickMark val="none"/>
        <c:tickLblPos val="nextTo"/>
        <c:crossAx val="130345600"/>
        <c:crosses val="autoZero"/>
        <c:crossBetween val="between"/>
        <c:majorUnit val="2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1800" b="1" i="0" u="none" strike="noStrike" baseline="0" dirty="0">
                <a:effectLst/>
              </a:rPr>
              <a:t>MAM-Bra013009</a:t>
            </a:r>
            <a:endParaRPr lang="en-US" dirty="0"/>
          </a:p>
        </c:rich>
      </c:tx>
      <c:layout>
        <c:manualLayout>
          <c:xMode val="edge"/>
          <c:yMode val="edge"/>
          <c:x val="0.25141966585514997"/>
          <c:y val="0.15771515202995545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ammen!$AS$3</c:f>
              <c:strCache>
                <c:ptCount val="1"/>
                <c:pt idx="0">
                  <c:v>Mam3-pr-5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mammen!$AT$4:$AT$15</c:f>
                <c:numCache>
                  <c:formatCode>General</c:formatCode>
                  <c:ptCount val="12"/>
                  <c:pt idx="0">
                    <c:v>0.76787585802220237</c:v>
                  </c:pt>
                  <c:pt idx="1">
                    <c:v>0.21361959960016108</c:v>
                  </c:pt>
                  <c:pt idx="2">
                    <c:v>0.468757222166585</c:v>
                  </c:pt>
                  <c:pt idx="3">
                    <c:v>4.0428001846904777</c:v>
                  </c:pt>
                  <c:pt idx="4">
                    <c:v>2.9273195930748654</c:v>
                  </c:pt>
                  <c:pt idx="5">
                    <c:v>3.9766359317057622</c:v>
                  </c:pt>
                  <c:pt idx="6">
                    <c:v>3.3778691508109091</c:v>
                  </c:pt>
                  <c:pt idx="7">
                    <c:v>5.1544188162520683</c:v>
                  </c:pt>
                  <c:pt idx="8">
                    <c:v>2.113393795139308</c:v>
                  </c:pt>
                  <c:pt idx="9">
                    <c:v>4.4096258344671364</c:v>
                  </c:pt>
                  <c:pt idx="10">
                    <c:v>4.0092434864115418</c:v>
                  </c:pt>
                  <c:pt idx="11">
                    <c:v>0.940070919310525</c:v>
                  </c:pt>
                </c:numCache>
              </c:numRef>
            </c:plus>
            <c:minus>
              <c:numRef>
                <c:f>mammen!$AT$4:$AT$15</c:f>
                <c:numCache>
                  <c:formatCode>General</c:formatCode>
                  <c:ptCount val="12"/>
                  <c:pt idx="0">
                    <c:v>0.76787585802220237</c:v>
                  </c:pt>
                  <c:pt idx="1">
                    <c:v>0.21361959960016108</c:v>
                  </c:pt>
                  <c:pt idx="2">
                    <c:v>0.468757222166585</c:v>
                  </c:pt>
                  <c:pt idx="3">
                    <c:v>4.0428001846904777</c:v>
                  </c:pt>
                  <c:pt idx="4">
                    <c:v>2.9273195930748654</c:v>
                  </c:pt>
                  <c:pt idx="5">
                    <c:v>3.9766359317057622</c:v>
                  </c:pt>
                  <c:pt idx="6">
                    <c:v>3.3778691508109091</c:v>
                  </c:pt>
                  <c:pt idx="7">
                    <c:v>5.1544188162520683</c:v>
                  </c:pt>
                  <c:pt idx="8">
                    <c:v>2.113393795139308</c:v>
                  </c:pt>
                  <c:pt idx="9">
                    <c:v>4.4096258344671364</c:v>
                  </c:pt>
                  <c:pt idx="10">
                    <c:v>4.0092434864115418</c:v>
                  </c:pt>
                  <c:pt idx="11">
                    <c:v>0.940070919310525</c:v>
                  </c:pt>
                </c:numCache>
              </c:numRef>
            </c:minus>
          </c:errBars>
          <c:cat>
            <c:strRef>
              <c:f>mammen!$AE$4:$AE$15</c:f>
              <c:strCache>
                <c:ptCount val="12"/>
                <c:pt idx="0">
                  <c:v>T2-YL</c:v>
                </c:pt>
                <c:pt idx="1">
                  <c:v>T6-YL</c:v>
                </c:pt>
                <c:pt idx="2">
                  <c:v>T6-OL</c:v>
                </c:pt>
                <c:pt idx="3">
                  <c:v>T2-YL</c:v>
                </c:pt>
                <c:pt idx="4">
                  <c:v>T6-YL</c:v>
                </c:pt>
                <c:pt idx="5">
                  <c:v>T6-OL</c:v>
                </c:pt>
                <c:pt idx="6">
                  <c:v>T2</c:v>
                </c:pt>
                <c:pt idx="7">
                  <c:v>T3</c:v>
                </c:pt>
                <c:pt idx="8">
                  <c:v>T6</c:v>
                </c:pt>
                <c:pt idx="9">
                  <c:v>T2</c:v>
                </c:pt>
                <c:pt idx="10">
                  <c:v>T3</c:v>
                </c:pt>
                <c:pt idx="11">
                  <c:v>T6</c:v>
                </c:pt>
              </c:strCache>
            </c:strRef>
          </c:cat>
          <c:val>
            <c:numRef>
              <c:f>mammen!$AS$4:$AS$15</c:f>
              <c:numCache>
                <c:formatCode>General</c:formatCode>
                <c:ptCount val="12"/>
                <c:pt idx="0">
                  <c:v>-2.0933333333333324</c:v>
                </c:pt>
                <c:pt idx="1">
                  <c:v>-5.6833333333333336</c:v>
                </c:pt>
                <c:pt idx="2">
                  <c:v>-7.3033333333333337</c:v>
                </c:pt>
                <c:pt idx="3">
                  <c:v>-12.136666666666665</c:v>
                </c:pt>
                <c:pt idx="4">
                  <c:v>-12.229999999999999</c:v>
                </c:pt>
                <c:pt idx="5">
                  <c:v>-9.1866666666666656</c:v>
                </c:pt>
                <c:pt idx="6">
                  <c:v>-8.61</c:v>
                </c:pt>
                <c:pt idx="7">
                  <c:v>-12.856666666666667</c:v>
                </c:pt>
                <c:pt idx="8">
                  <c:v>-15.053333333333333</c:v>
                </c:pt>
                <c:pt idx="9">
                  <c:v>-17.400000000000002</c:v>
                </c:pt>
                <c:pt idx="10">
                  <c:v>-14.293333333333331</c:v>
                </c:pt>
                <c:pt idx="11">
                  <c:v>-16.74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D8-4A01-A26C-F47BC82AA0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650496"/>
        <c:axId val="130652032"/>
      </c:barChart>
      <c:catAx>
        <c:axId val="1306504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5400000" vert="horz"/>
          <a:lstStyle/>
          <a:p>
            <a:pPr>
              <a:defRPr/>
            </a:pPr>
            <a:endParaRPr lang="nl-NL"/>
          </a:p>
        </c:txPr>
        <c:crossAx val="130652032"/>
        <c:crossesAt val="-12"/>
        <c:auto val="1"/>
        <c:lblAlgn val="ctr"/>
        <c:lblOffset val="100"/>
        <c:noMultiLvlLbl val="0"/>
      </c:catAx>
      <c:valAx>
        <c:axId val="130652032"/>
        <c:scaling>
          <c:orientation val="minMax"/>
          <c:max val="0"/>
          <c:min val="-12"/>
        </c:scaling>
        <c:delete val="0"/>
        <c:axPos val="l"/>
        <c:numFmt formatCode="General" sourceLinked="1"/>
        <c:majorTickMark val="out"/>
        <c:minorTickMark val="none"/>
        <c:tickLblPos val="nextTo"/>
        <c:crossAx val="130650496"/>
        <c:crosses val="autoZero"/>
        <c:crossBetween val="between"/>
        <c:majorUnit val="2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1800" b="1" i="0" u="none" strike="noStrike" baseline="0" dirty="0">
                <a:effectLst/>
              </a:rPr>
              <a:t>MAM-Bra021947</a:t>
            </a:r>
            <a:endParaRPr lang="en-US" dirty="0"/>
          </a:p>
        </c:rich>
      </c:tx>
      <c:layout>
        <c:manualLayout>
          <c:xMode val="edge"/>
          <c:yMode val="edge"/>
          <c:x val="0.24769854592111049"/>
          <c:y val="0.17664097027355011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ammen!$AS$56</c:f>
              <c:strCache>
                <c:ptCount val="1"/>
                <c:pt idx="0">
                  <c:v>mam3 pr56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mammen!$AT$57:$AT$68</c:f>
                <c:numCache>
                  <c:formatCode>General</c:formatCode>
                  <c:ptCount val="12"/>
                  <c:pt idx="0">
                    <c:v>0.44508426168535825</c:v>
                  </c:pt>
                  <c:pt idx="1">
                    <c:v>0.19347695814575014</c:v>
                  </c:pt>
                  <c:pt idx="2">
                    <c:v>0.35510561809129421</c:v>
                  </c:pt>
                  <c:pt idx="3">
                    <c:v>0.15947831618540995</c:v>
                  </c:pt>
                  <c:pt idx="4">
                    <c:v>0.34828149534536068</c:v>
                  </c:pt>
                  <c:pt idx="5">
                    <c:v>1.381122731693313</c:v>
                  </c:pt>
                  <c:pt idx="6">
                    <c:v>0.87412813706000336</c:v>
                  </c:pt>
                  <c:pt idx="7">
                    <c:v>0.41677331968349357</c:v>
                  </c:pt>
                  <c:pt idx="8">
                    <c:v>0.96836632187067062</c:v>
                  </c:pt>
                  <c:pt idx="9">
                    <c:v>7.3711147958322065E-2</c:v>
                  </c:pt>
                  <c:pt idx="10">
                    <c:v>0.57204312191768614</c:v>
                  </c:pt>
                  <c:pt idx="11">
                    <c:v>1.0862933919219642</c:v>
                  </c:pt>
                </c:numCache>
              </c:numRef>
            </c:plus>
            <c:minus>
              <c:numRef>
                <c:f>mammen!$AT$57:$AT$68</c:f>
                <c:numCache>
                  <c:formatCode>General</c:formatCode>
                  <c:ptCount val="12"/>
                  <c:pt idx="0">
                    <c:v>0.44508426168535825</c:v>
                  </c:pt>
                  <c:pt idx="1">
                    <c:v>0.19347695814575014</c:v>
                  </c:pt>
                  <c:pt idx="2">
                    <c:v>0.35510561809129421</c:v>
                  </c:pt>
                  <c:pt idx="3">
                    <c:v>0.15947831618540995</c:v>
                  </c:pt>
                  <c:pt idx="4">
                    <c:v>0.34828149534536068</c:v>
                  </c:pt>
                  <c:pt idx="5">
                    <c:v>1.381122731693313</c:v>
                  </c:pt>
                  <c:pt idx="6">
                    <c:v>0.87412813706000336</c:v>
                  </c:pt>
                  <c:pt idx="7">
                    <c:v>0.41677331968349357</c:v>
                  </c:pt>
                  <c:pt idx="8">
                    <c:v>0.96836632187067062</c:v>
                  </c:pt>
                  <c:pt idx="9">
                    <c:v>7.3711147958322065E-2</c:v>
                  </c:pt>
                  <c:pt idx="10">
                    <c:v>0.57204312191768614</c:v>
                  </c:pt>
                  <c:pt idx="11">
                    <c:v>1.0862933919219642</c:v>
                  </c:pt>
                </c:numCache>
              </c:numRef>
            </c:minus>
          </c:errBars>
          <c:cat>
            <c:strRef>
              <c:f>mammen!$AR$57:$AR$68</c:f>
              <c:strCache>
                <c:ptCount val="12"/>
                <c:pt idx="0">
                  <c:v>T2-YL</c:v>
                </c:pt>
                <c:pt idx="1">
                  <c:v>T6-YL</c:v>
                </c:pt>
                <c:pt idx="2">
                  <c:v>T6-OL</c:v>
                </c:pt>
                <c:pt idx="3">
                  <c:v>T2-YL</c:v>
                </c:pt>
                <c:pt idx="4">
                  <c:v>T6-YL</c:v>
                </c:pt>
                <c:pt idx="5">
                  <c:v>T6-OL</c:v>
                </c:pt>
                <c:pt idx="6">
                  <c:v>T2</c:v>
                </c:pt>
                <c:pt idx="7">
                  <c:v>T3</c:v>
                </c:pt>
                <c:pt idx="8">
                  <c:v>T6</c:v>
                </c:pt>
                <c:pt idx="9">
                  <c:v>T2</c:v>
                </c:pt>
                <c:pt idx="10">
                  <c:v>T3</c:v>
                </c:pt>
                <c:pt idx="11">
                  <c:v>T6</c:v>
                </c:pt>
              </c:strCache>
            </c:strRef>
          </c:cat>
          <c:val>
            <c:numRef>
              <c:f>mammen!$AS$57:$AS$68</c:f>
              <c:numCache>
                <c:formatCode>General</c:formatCode>
                <c:ptCount val="12"/>
                <c:pt idx="0">
                  <c:v>-3.7599999999999993</c:v>
                </c:pt>
                <c:pt idx="1">
                  <c:v>-5.4866666666666672</c:v>
                </c:pt>
                <c:pt idx="2">
                  <c:v>-6.1000000000000014</c:v>
                </c:pt>
                <c:pt idx="3">
                  <c:v>-3.4266666666666672</c:v>
                </c:pt>
                <c:pt idx="4">
                  <c:v>-3.91</c:v>
                </c:pt>
                <c:pt idx="5">
                  <c:v>-3.819999999999999</c:v>
                </c:pt>
                <c:pt idx="6">
                  <c:v>-5.54</c:v>
                </c:pt>
                <c:pt idx="7">
                  <c:v>-8.17</c:v>
                </c:pt>
                <c:pt idx="8">
                  <c:v>-16.846666666666668</c:v>
                </c:pt>
                <c:pt idx="9">
                  <c:v>-5.4966666666666661</c:v>
                </c:pt>
                <c:pt idx="10">
                  <c:v>-4.9466666666666681</c:v>
                </c:pt>
                <c:pt idx="11">
                  <c:v>-12.8566666666666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CE-488D-84E5-16488E6E92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672512"/>
        <c:axId val="130674048"/>
      </c:barChart>
      <c:catAx>
        <c:axId val="1306725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5400000" vert="horz"/>
          <a:lstStyle/>
          <a:p>
            <a:pPr>
              <a:defRPr/>
            </a:pPr>
            <a:endParaRPr lang="nl-NL"/>
          </a:p>
        </c:txPr>
        <c:crossAx val="130674048"/>
        <c:crossesAt val="-12"/>
        <c:auto val="1"/>
        <c:lblAlgn val="ctr"/>
        <c:lblOffset val="100"/>
        <c:noMultiLvlLbl val="0"/>
      </c:catAx>
      <c:valAx>
        <c:axId val="130674048"/>
        <c:scaling>
          <c:orientation val="minMax"/>
          <c:max val="0"/>
          <c:min val="-12"/>
        </c:scaling>
        <c:delete val="0"/>
        <c:axPos val="l"/>
        <c:numFmt formatCode="General" sourceLinked="1"/>
        <c:majorTickMark val="out"/>
        <c:minorTickMark val="none"/>
        <c:tickLblPos val="nextTo"/>
        <c:crossAx val="130672512"/>
        <c:crosses val="autoZero"/>
        <c:crossBetween val="between"/>
        <c:majorUnit val="2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88034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58423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28161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89644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91341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47000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39582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311278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03331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49959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356003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23173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/>
          </p:nvPr>
        </p:nvGraphicFramePr>
        <p:xfrm>
          <a:off x="-1279" y="2720754"/>
          <a:ext cx="3412951" cy="2013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/>
          </p:nvPr>
        </p:nvGraphicFramePr>
        <p:xfrm>
          <a:off x="32964" y="488505"/>
          <a:ext cx="3412951" cy="2013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2" y="4880993"/>
          <a:ext cx="3412951" cy="2013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/>
          </p:nvPr>
        </p:nvGraphicFramePr>
        <p:xfrm>
          <a:off x="3461288" y="2432722"/>
          <a:ext cx="3412951" cy="2013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/>
          </p:nvPr>
        </p:nvGraphicFramePr>
        <p:xfrm>
          <a:off x="3501010" y="4664970"/>
          <a:ext cx="3412951" cy="2013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/>
          </p:nvPr>
        </p:nvGraphicFramePr>
        <p:xfrm>
          <a:off x="3441127" y="381001"/>
          <a:ext cx="3412951" cy="2013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/>
          </p:nvPr>
        </p:nvGraphicFramePr>
        <p:xfrm>
          <a:off x="3454104" y="6825210"/>
          <a:ext cx="3412951" cy="2013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9" name="Table 8"/>
          <p:cNvGraphicFramePr>
            <a:graphicFrameLocks noGrp="1"/>
          </p:cNvGraphicFramePr>
          <p:nvPr>
            <p:extLst/>
          </p:nvPr>
        </p:nvGraphicFramePr>
        <p:xfrm>
          <a:off x="332657" y="6883112"/>
          <a:ext cx="2952328" cy="5181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5608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5608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5608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8407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59080"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leaf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Turnip cor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0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8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0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8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0" name="Table 9"/>
          <p:cNvGraphicFramePr>
            <a:graphicFrameLocks noGrp="1"/>
          </p:cNvGraphicFramePr>
          <p:nvPr>
            <p:extLst/>
          </p:nvPr>
        </p:nvGraphicFramePr>
        <p:xfrm>
          <a:off x="332657" y="4650864"/>
          <a:ext cx="2952328" cy="5181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5608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5608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5608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8407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59080"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leaf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Turnip cor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0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8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0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8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1" name="Table 10"/>
          <p:cNvGraphicFramePr>
            <a:graphicFrameLocks noGrp="1"/>
          </p:cNvGraphicFramePr>
          <p:nvPr>
            <p:extLst/>
          </p:nvPr>
        </p:nvGraphicFramePr>
        <p:xfrm>
          <a:off x="332657" y="2418616"/>
          <a:ext cx="2952328" cy="5181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5608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5608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5608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8407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59080"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leaf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Turnip cor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0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8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0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8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2" name="Table 11"/>
          <p:cNvGraphicFramePr>
            <a:graphicFrameLocks noGrp="1"/>
          </p:cNvGraphicFramePr>
          <p:nvPr>
            <p:extLst/>
          </p:nvPr>
        </p:nvGraphicFramePr>
        <p:xfrm>
          <a:off x="3861048" y="8827328"/>
          <a:ext cx="2952328" cy="5181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5608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5608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5608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8407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59080"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leaf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Turnip cor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0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8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0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8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>
            <p:extLst/>
          </p:nvPr>
        </p:nvGraphicFramePr>
        <p:xfrm>
          <a:off x="3861048" y="6609184"/>
          <a:ext cx="2952328" cy="5181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5608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5608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5608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8407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59080"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leaf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Turnip cor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0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8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0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8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4" name="Table 13"/>
          <p:cNvGraphicFramePr>
            <a:graphicFrameLocks noGrp="1"/>
          </p:cNvGraphicFramePr>
          <p:nvPr>
            <p:extLst/>
          </p:nvPr>
        </p:nvGraphicFramePr>
        <p:xfrm>
          <a:off x="3789041" y="4376936"/>
          <a:ext cx="2952328" cy="5181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5608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5608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5608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8407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59080"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leaf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Turnip cor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0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8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0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8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5" name="Table 14"/>
          <p:cNvGraphicFramePr>
            <a:graphicFrameLocks noGrp="1"/>
          </p:cNvGraphicFramePr>
          <p:nvPr>
            <p:extLst/>
          </p:nvPr>
        </p:nvGraphicFramePr>
        <p:xfrm>
          <a:off x="3789041" y="2288704"/>
          <a:ext cx="2952328" cy="5181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5608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5608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5608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8407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59080"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leaf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Turnip cor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0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8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0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100" dirty="0">
                          <a:solidFill>
                            <a:schemeClr val="tx1"/>
                          </a:solidFill>
                        </a:rPr>
                        <a:t>FT-08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291957" y="7703820"/>
            <a:ext cx="310846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upplemental Fig. S3 </a:t>
            </a:r>
            <a:r>
              <a:rPr lang="en-US" sz="1200" dirty="0"/>
              <a:t>Gene expression analysis of MAM paralogues in selected turnip tissues and </a:t>
            </a:r>
            <a:r>
              <a:rPr lang="en-US" sz="1200" dirty="0" err="1"/>
              <a:t>timepoints</a:t>
            </a:r>
            <a:r>
              <a:rPr lang="en-US" sz="1200" dirty="0"/>
              <a:t> in accessions FT-004 and FT-086. Indicated are the expression levels relative to the reference gene (actin) on a logarithmic scale. Error bars indicate standard deviations (n = 3). YL: young leaf; OL: old leaf. For </a:t>
            </a:r>
            <a:r>
              <a:rPr lang="en-US" sz="1200" dirty="0" err="1"/>
              <a:t>timepoints</a:t>
            </a:r>
            <a:r>
              <a:rPr lang="en-US" sz="1200" dirty="0"/>
              <a:t> see legend Fig. 3.</a:t>
            </a:r>
          </a:p>
        </p:txBody>
      </p:sp>
    </p:spTree>
    <p:extLst>
      <p:ext uri="{BB962C8B-B14F-4D97-AF65-F5344CB8AC3E}">
        <p14:creationId xmlns:p14="http://schemas.microsoft.com/office/powerpoint/2010/main" val="32860705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24</Words>
  <Application>Microsoft Office PowerPoint</Application>
  <PresentationFormat>A4 Paper (210x297 mm)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ekwilder, Jules</dc:creator>
  <cp:lastModifiedBy>Beekwilder, Jules</cp:lastModifiedBy>
  <cp:revision>1</cp:revision>
  <dcterms:created xsi:type="dcterms:W3CDTF">2019-05-22T15:37:29Z</dcterms:created>
  <dcterms:modified xsi:type="dcterms:W3CDTF">2019-05-22T15:40:30Z</dcterms:modified>
</cp:coreProperties>
</file>